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송재진(의생명과학부)" initials="송" lastIdx="0" clrIdx="0">
    <p:extLst>
      <p:ext uri="{19B8F6BF-5375-455C-9EA6-DF929625EA0E}">
        <p15:presenceInfo xmlns:p15="http://schemas.microsoft.com/office/powerpoint/2012/main" userId="S-1-5-21-1961260681-1744463731-1174482739-5253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25" autoAdjust="0"/>
    <p:restoredTop sz="96754" autoAdjust="0"/>
  </p:normalViewPr>
  <p:slideViewPr>
    <p:cSldViewPr>
      <p:cViewPr varScale="1">
        <p:scale>
          <a:sx n="84" d="100"/>
          <a:sy n="84" d="100"/>
        </p:scale>
        <p:origin x="3594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75" d="100"/>
          <a:sy n="75" d="100"/>
        </p:scale>
        <p:origin x="-2238" y="-96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7B5297-8AF9-4662-8439-A42EEAB29B89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FB9AF-191C-4A97-901B-B76D64413D3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8605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91B20B3F-015D-4D5C-8145-BEDC1A5A80D2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97F86E4C-FF9F-40A3-A151-3E4B9A7E95E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50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0" name="TextBox 1199"/>
          <p:cNvSpPr txBox="1"/>
          <p:nvPr/>
        </p:nvSpPr>
        <p:spPr>
          <a:xfrm>
            <a:off x="268435" y="611560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1" name="TextBox 1200"/>
          <p:cNvSpPr txBox="1"/>
          <p:nvPr/>
        </p:nvSpPr>
        <p:spPr>
          <a:xfrm>
            <a:off x="688504" y="1835696"/>
            <a:ext cx="15270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NL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Daxx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promoter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2" name="직사각형 1201"/>
          <p:cNvSpPr/>
          <p:nvPr/>
        </p:nvSpPr>
        <p:spPr>
          <a:xfrm>
            <a:off x="688504" y="2230208"/>
            <a:ext cx="4570219" cy="12464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TGCTGTGCTC ATTTGTATGC GTGTGTTCGT GTGTGTGTGC ACCTGGCCCA GGAGGCC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G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GG CTGGACAGCC TCGAGGTGCA CGCCTCCTCT CGAAGGAAGG GAAGGGCCAG CGTAGGCAGC CAGGCGGTGG AACTCCAGGG GCCGGAGGGA GAGCAGAGAA GGCGGTGCAA GGCTTACACC AACCCAGGGC AGGAAAAGCA TATCTTTTAT TTCGTTCCCT GGAGCCCTGC ACAGCCATAG AGACA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AGC TCCTTAGCTA CCTGCAGGAG ATTCCTTACC CTCCTAGGGT GGAGGGACCG GTCTT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CCG ATGCGACTCC ACGCGATGGC TTGGGGTTGT GGGGCAGGTC TGAGGCTGGA GTTTCTGATT GGCCGAGCGG CTTCGGCAAG CTCCTGGTGC AAAGAGCTCC ACGCCTCGCC GCGGAGCAGG CCGGTGCCGT ACGGCAACAT GGCGCGCCCC ATCTACCTGG TCCTCCGCCC CGCCCCGTCG AGCCTCCGCG TCCCCGGAGC GGTGGCCTCG GT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GGCGAG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 CGAGCGTCAC TTCCGGCTCT AAGCGGCCTG GGTCCCGTAC AGCAATATGG CCGCCCTCAG GTGCTCCAGG CGGAAGCGCT AAGGC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TTCCG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TC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TGTTGTG GGGTCTGCGG TGGGGGTTGG GGAGAGGAAG GCGGAGGGAA CT</a:t>
            </a:r>
            <a:r>
              <a:rPr lang="en-US" altLang="ko-KR" sz="750" b="1" dirty="0" smtClean="0">
                <a:latin typeface="Courier New" pitchFamily="49" charset="0"/>
                <a:cs typeface="Courier New" pitchFamily="49" charset="0"/>
              </a:rPr>
              <a:t>ATG</a:t>
            </a:r>
            <a:endParaRPr lang="ko-KR" altLang="en-US" sz="750" b="1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203" name="직사각형 1202"/>
          <p:cNvSpPr/>
          <p:nvPr/>
        </p:nvSpPr>
        <p:spPr>
          <a:xfrm>
            <a:off x="688506" y="4301970"/>
            <a:ext cx="4570217" cy="12464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TGCTGTGCTC ATTTGTATGC GTGTGTTCGT GTGTGTGTGC ACCTGGCCCA GGAGGCC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C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GG CTGGACAGCC TCGAGGTGCA CGCCTCCTCT CGAAGGAAGG GAAGGGCCAG CGTAGGCAGC CAGGCGGTGG AACTCCAGGG GCCGGAGGGA GAGCAGAGAA GGCGGTGCAA GGCTTACACC AACCCAGGGC AGGAAAAGCA TATCTTTTAT TTCGTTCCCT GGAGCCCTGC ACAGCCATAG AGACA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T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AGC TCCTTAGCTA CCTGCAGGAG ATTCCTTACC CTCCTAGGGT GGAGGGACCG GTCTT</a:t>
            </a:r>
            <a:r>
              <a:rPr lang="en-US" altLang="ko-KR" sz="750" dirty="0" smtClean="0">
                <a:solidFill>
                  <a:srgbClr val="00B0F0"/>
                </a:solidFill>
                <a:latin typeface="Courier New" pitchFamily="49" charset="0"/>
                <a:cs typeface="Courier New" pitchFamily="49" charset="0"/>
              </a:rPr>
              <a:t>A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CCG ATGCGACTCC ACGCGATGGC TTGGGGTTGT GGGGCAGGTC TGAGGCTGGA GTTTCCGATT GGCCGAGCGG CTTCGGCAAG CTCCTGGTGC AAAGAGCTCC ACGCCTCGCC GCGGAGCAGG CCGGTGCCGT ACGGCAACAT GGCGCGCCCC ATCTACCTGG TCCTCCGCCC CGCCCCGTCG AGCCTCCGCG TCCCCGGAGC GGTGGCCTCG GT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GGCGAG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C CGAGCGTCAC TTCCGGCTCT AAGCGGCCTG GGTCCCGTAC AGCAATATGG CCGCCCTCAG GTGCTCCAGG CGGAAGCGCT AAGGC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TTCCG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ko-KR" sz="750" dirty="0" smtClean="0">
                <a:solidFill>
                  <a:srgbClr val="FF0000"/>
                </a:solidFill>
                <a:latin typeface="Courier New" pitchFamily="49" charset="0"/>
                <a:cs typeface="Courier New" pitchFamily="49" charset="0"/>
              </a:rPr>
              <a:t>GTC</a:t>
            </a:r>
            <a:r>
              <a:rPr lang="en-US" altLang="ko-KR" sz="750" dirty="0" smtClean="0">
                <a:latin typeface="Courier New" pitchFamily="49" charset="0"/>
                <a:cs typeface="Courier New" pitchFamily="49" charset="0"/>
              </a:rPr>
              <a:t>TGTTGTG </a:t>
            </a:r>
            <a:r>
              <a:rPr lang="en-US" altLang="ko-KR" sz="750" dirty="0">
                <a:latin typeface="Courier New" pitchFamily="49" charset="0"/>
                <a:cs typeface="Courier New" pitchFamily="49" charset="0"/>
              </a:rPr>
              <a:t>GGGTCTGCGG TGGGGGTTGG GGAGAGGAAG GCGGAGGGAA CT</a:t>
            </a:r>
            <a:r>
              <a:rPr lang="en-US" altLang="ko-KR" sz="750" b="1" dirty="0">
                <a:latin typeface="Courier New" pitchFamily="49" charset="0"/>
                <a:cs typeface="Courier New" pitchFamily="49" charset="0"/>
              </a:rPr>
              <a:t>ATG</a:t>
            </a:r>
            <a:endParaRPr lang="ko-KR" altLang="en-US" sz="750" b="1" dirty="0">
              <a:latin typeface="Courier New" pitchFamily="49" charset="0"/>
              <a:cs typeface="Courier New" pitchFamily="49" charset="0"/>
            </a:endParaRPr>
          </a:p>
        </p:txBody>
      </p:sp>
      <p:sp>
        <p:nvSpPr>
          <p:cNvPr id="1204" name="TextBox 1203"/>
          <p:cNvSpPr txBox="1"/>
          <p:nvPr/>
        </p:nvSpPr>
        <p:spPr>
          <a:xfrm>
            <a:off x="688504" y="3923928"/>
            <a:ext cx="17796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B16BL6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Daxx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promoter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82</TotalTime>
  <Words>145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ourier New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1524</cp:revision>
  <cp:lastPrinted>2019-05-07T06:31:19Z</cp:lastPrinted>
  <dcterms:created xsi:type="dcterms:W3CDTF">2016-01-12T05:31:29Z</dcterms:created>
  <dcterms:modified xsi:type="dcterms:W3CDTF">2019-05-29T08:09:42Z</dcterms:modified>
</cp:coreProperties>
</file>